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FF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191" autoAdjust="0"/>
    <p:restoredTop sz="94660"/>
  </p:normalViewPr>
  <p:slideViewPr>
    <p:cSldViewPr snapToGrid="0">
      <p:cViewPr varScale="1">
        <p:scale>
          <a:sx n="81" d="100"/>
          <a:sy n="81" d="100"/>
        </p:scale>
        <p:origin x="78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6A09B-E284-416F-8C32-29AC445708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8BB011-C7D7-448A-B426-7DE6A77C63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E95395-2E06-4E27-A792-A836B4CAC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460058-E60E-4BEC-9DB9-C12ED8B0E8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CC1A04-B3E1-42AD-BA93-9E7D64C2B0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623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AD37B-4E65-4020-B6A5-3F083FE66B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14EE4D-305D-4D04-95E8-9B69557FB9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91EA92-5F27-41EA-B053-8A50E64E9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2D1E53-7737-4BAD-B632-C59F27690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65EC67-0074-4A65-A49A-94E428E81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0492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B5550E4-3679-4BE2-8921-AE4CD6A66A4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094B704-A5E5-4AEC-BCAE-A81D3FB336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D09D14-7D42-438C-B84D-CEF9F49293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8B51E9-A783-482F-9A56-07B89BD98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7DBE55-0A17-472C-8294-DDD0C212EB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05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A0B7D8-94D7-427C-878B-64AADCEF14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FFDD3B-913E-44DA-B3D8-00F9C6C5C2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C4ABE9-3E33-4B4C-BAD2-21C42A183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061D92-250B-40D8-B196-52F8050BE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C9BB35-2D5E-4DEE-B35D-05FFEFB8D8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7713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DD348F-C433-4107-90A8-25091D564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2C8AC7-F228-46DB-8F03-8529A865A5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892A3B-A01D-46E3-B3DC-B5AAC258D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C9E38C-F6C7-48A2-9C15-43BD205D9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5F01D3-B556-4F75-8847-1222F7EB4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6559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128E24-A9CF-4483-BD3D-ECCCD5CF50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17891D-9FF2-4F5E-8F1B-AD49CB59462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F5192A-4BC1-4F92-9378-4D31049B26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37CFFF-9E83-4C87-8DBC-C7F219741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04F614-98C5-4A6C-BCF4-E7778E5FC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D7F0EB-5455-42E5-96EA-22AABEB12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4190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C38B02-1545-48AA-84E6-2D161C3CBF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E4B353-5AB3-40D8-9D46-1290C86CB8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C0B6D8-150F-4A2A-8E0D-1F76185B0D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F5B9B6-8465-4D48-83B9-B9ED2BDCC2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101359-122C-4C73-916F-2C8F470FC7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C49CE6B-AAAD-4D29-9492-D27A2A21AF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A87D95-476C-49E3-891A-6D6EF0B18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8E7295-8C1D-49CC-8EDE-B5716BF7BD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907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36106E-C96B-4379-8370-30DF38B02B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1022F2-05AF-44B5-ACB9-4AC5768A06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E43A30-344B-41DF-ADF8-9F988ADF6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0DCA8BB-B2FB-4F38-87E4-EBF21167A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002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78B2F87-2165-455D-9400-88B50CE96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AAC6992-B7AF-4962-98B9-18ED71D1B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C5668E6-0070-46D4-B957-F48D84E4D2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444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152D22-E366-4C61-838B-3AD3437CC7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62C9F3-4F80-4B2E-8DCA-3A6777FF08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74F78A5-3101-482F-B611-7BDEC70091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B7671A-1875-4CCD-9439-6FB1CD2FE9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81656D-92C0-4927-9662-666B7E4342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BFFF80-465C-4379-AC2A-A1F29B31A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1897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A6D0BE-C320-49B2-9BE1-861A9BBF30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4B44997-C4FE-4555-90D1-08D0D07325E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85C3DDD-B84F-46D4-90D9-981EBD770A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44683A-BDCC-4815-8311-574AFE98F4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9E89C9-2578-4851-B714-75523DB0C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CE29F7-F9B0-42C1-BEA5-08658F517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86371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27DFB1F-50F2-407E-B16C-B028C49DFD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9436BD-B6F4-42D1-A227-39A4C9FE40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40A5EC-06C2-494E-8E25-5EF0E2C733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192BD-FB38-4CB7-BA97-7860E96FE4B3}" type="datetimeFigureOut">
              <a:rPr lang="en-US" smtClean="0"/>
              <a:t>6/2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8DFB25-99D9-4AB8-819D-7A69484257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1C0AD1-0B45-43D5-92FE-3B12E260EE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C63E99-2FA5-4F2D-B2B5-377632D415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1236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03B4E8D-E146-4B3B-B0D2-2758C7B608DA}"/>
              </a:ext>
            </a:extLst>
          </p:cNvPr>
          <p:cNvSpPr txBox="1"/>
          <p:nvPr/>
        </p:nvSpPr>
        <p:spPr>
          <a:xfrm>
            <a:off x="564554" y="273377"/>
            <a:ext cx="7344535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Palatino Linotype" panose="02040502050505030304" pitchFamily="18" charset="0"/>
              </a:rPr>
              <a:t>Figure S1 </a:t>
            </a:r>
            <a:r>
              <a:rPr lang="en-US" sz="1400" dirty="0">
                <a:latin typeface="Palatino Linotype" panose="02040502050505030304" pitchFamily="18" charset="0"/>
              </a:rPr>
              <a:t>Plots of PC1 (that accounted for 4.6-11.3% depending on the population), PC2 (4.2-7.6%), and PC3 (3.7-6.6%) from principal component analysis to show population structure of the 6 spring wheat populations based on 1058 to 23795 polymorphic markers. See Table S4C for the number of markers used in each population. 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47CDED9F-9AB5-421F-97FD-C8376D0B44EA}"/>
              </a:ext>
            </a:extLst>
          </p:cNvPr>
          <p:cNvGrpSpPr/>
          <p:nvPr/>
        </p:nvGrpSpPr>
        <p:grpSpPr>
          <a:xfrm>
            <a:off x="318233" y="131975"/>
            <a:ext cx="11700942" cy="6501038"/>
            <a:chOff x="318233" y="131975"/>
            <a:chExt cx="11700942" cy="6501038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B9D86DBB-7710-4716-9457-72FA066086E5}"/>
                </a:ext>
              </a:extLst>
            </p:cNvPr>
            <p:cNvGrpSpPr/>
            <p:nvPr/>
          </p:nvGrpSpPr>
          <p:grpSpPr>
            <a:xfrm>
              <a:off x="7836695" y="131975"/>
              <a:ext cx="4182480" cy="3959258"/>
              <a:chOff x="7082550" y="301658"/>
              <a:chExt cx="4182480" cy="3959258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4913641B-C00B-412A-8F3C-7E1EC53C82C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23032" r="14559" b="7354"/>
              <a:stretch/>
            </p:blipFill>
            <p:spPr>
              <a:xfrm>
                <a:off x="7082550" y="301658"/>
                <a:ext cx="4182480" cy="3959258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8680ED96-4E7E-429F-BEC0-AAB21BC8F2A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2612" r="88363" b="90515"/>
              <a:stretch/>
            </p:blipFill>
            <p:spPr>
              <a:xfrm>
                <a:off x="9363084" y="3553905"/>
                <a:ext cx="1251498" cy="471340"/>
              </a:xfrm>
              <a:prstGeom prst="rect">
                <a:avLst/>
              </a:prstGeom>
            </p:spPr>
          </p:pic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6012DCD7-AD4B-4899-8A75-1D70692189C8}"/>
                </a:ext>
              </a:extLst>
            </p:cNvPr>
            <p:cNvGrpSpPr/>
            <p:nvPr/>
          </p:nvGrpSpPr>
          <p:grpSpPr>
            <a:xfrm>
              <a:off x="5750351" y="3525624"/>
              <a:ext cx="4383465" cy="3107389"/>
              <a:chOff x="5750351" y="3525624"/>
              <a:chExt cx="4383465" cy="3107389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B2CF8F99-E875-47DF-AD7C-63DDFB60ED0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7072" r="13944" b="4399"/>
              <a:stretch/>
            </p:blipFill>
            <p:spPr>
              <a:xfrm>
                <a:off x="5750351" y="3525624"/>
                <a:ext cx="3516198" cy="3107389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D9799BB3-67D2-4C19-AB2B-5FEB6070ED4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2612" r="85558" b="90515"/>
              <a:stretch/>
            </p:blipFill>
            <p:spPr>
              <a:xfrm>
                <a:off x="8580660" y="5759777"/>
                <a:ext cx="1553156" cy="471340"/>
              </a:xfrm>
              <a:prstGeom prst="rect">
                <a:avLst/>
              </a:prstGeom>
            </p:spPr>
          </p:pic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B769962B-74E7-4D2E-8056-DDBEE6A890C7}"/>
                </a:ext>
              </a:extLst>
            </p:cNvPr>
            <p:cNvGrpSpPr/>
            <p:nvPr/>
          </p:nvGrpSpPr>
          <p:grpSpPr>
            <a:xfrm>
              <a:off x="318233" y="1638962"/>
              <a:ext cx="5214435" cy="4716003"/>
              <a:chOff x="535915" y="816330"/>
              <a:chExt cx="5214435" cy="4716003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8267645E-704C-4645-A45B-F5CB8EA3FAC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6984" r="14822" b="3281"/>
              <a:stretch/>
            </p:blipFill>
            <p:spPr>
              <a:xfrm>
                <a:off x="535915" y="816330"/>
                <a:ext cx="5214435" cy="4716003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98872432-447E-4663-90CD-883E02393AE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2337" r="85295" b="83643"/>
              <a:stretch/>
            </p:blipFill>
            <p:spPr>
              <a:xfrm>
                <a:off x="1086351" y="4570798"/>
                <a:ext cx="1581436" cy="961535"/>
              </a:xfrm>
              <a:prstGeom prst="rect">
                <a:avLst/>
              </a:prstGeom>
            </p:spPr>
          </p:pic>
        </p:grpSp>
        <p:sp>
          <p:nvSpPr>
            <p:cNvPr id="12" name="Arrow: Right 11">
              <a:extLst>
                <a:ext uri="{FF2B5EF4-FFF2-40B4-BE49-F238E27FC236}">
                  <a16:creationId xmlns:a16="http://schemas.microsoft.com/office/drawing/2014/main" id="{EA2E4255-0218-4715-A07C-85140B8ED83A}"/>
                </a:ext>
              </a:extLst>
            </p:cNvPr>
            <p:cNvSpPr/>
            <p:nvPr/>
          </p:nvSpPr>
          <p:spPr>
            <a:xfrm>
              <a:off x="4684255" y="4994477"/>
              <a:ext cx="848412" cy="169682"/>
            </a:xfrm>
            <a:prstGeom prst="rightArrow">
              <a:avLst/>
            </a:prstGeom>
            <a:solidFill>
              <a:srgbClr val="FFC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4" name="Arrow: Right 13">
              <a:extLst>
                <a:ext uri="{FF2B5EF4-FFF2-40B4-BE49-F238E27FC236}">
                  <a16:creationId xmlns:a16="http://schemas.microsoft.com/office/drawing/2014/main" id="{30491330-4A48-4FA0-982B-6AAEB9477142}"/>
                </a:ext>
              </a:extLst>
            </p:cNvPr>
            <p:cNvSpPr/>
            <p:nvPr/>
          </p:nvSpPr>
          <p:spPr>
            <a:xfrm rot="20449880">
              <a:off x="5510672" y="2663263"/>
              <a:ext cx="1630837" cy="141402"/>
            </a:xfrm>
            <a:prstGeom prst="rightArrow">
              <a:avLst/>
            </a:prstGeom>
            <a:solidFill>
              <a:srgbClr val="FFC000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43B280A0-8C4E-4FDB-9CBE-D6F1B9E78192}"/>
              </a:ext>
            </a:extLst>
          </p:cNvPr>
          <p:cNvSpPr txBox="1"/>
          <p:nvPr/>
        </p:nvSpPr>
        <p:spPr>
          <a:xfrm>
            <a:off x="651420" y="1485073"/>
            <a:ext cx="20159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ll 6 populations</a:t>
            </a:r>
          </a:p>
        </p:txBody>
      </p:sp>
    </p:spTree>
    <p:extLst>
      <p:ext uri="{BB962C8B-B14F-4D97-AF65-F5344CB8AC3E}">
        <p14:creationId xmlns:p14="http://schemas.microsoft.com/office/powerpoint/2010/main" val="31888066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94</TotalTime>
  <Words>6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ssa Fentaye</dc:creator>
  <cp:lastModifiedBy>KS</cp:lastModifiedBy>
  <cp:revision>619</cp:revision>
  <dcterms:created xsi:type="dcterms:W3CDTF">2020-10-03T17:39:44Z</dcterms:created>
  <dcterms:modified xsi:type="dcterms:W3CDTF">2022-06-25T18:31:48Z</dcterms:modified>
</cp:coreProperties>
</file>